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822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83473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8536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01150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1500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7782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99475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20129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0643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01513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6504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1117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3C0EE-56C9-4CA9-B321-E0B01715CDE1}" type="datetimeFigureOut">
              <a:rPr lang="en-AU" smtClean="0"/>
              <a:t>2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3D457-EBF6-4352-8330-C0449FA05CA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4394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-2503124" y="2919183"/>
            <a:ext cx="60040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b="1" dirty="0"/>
              <a:t>Time frame : Baseline to post intervention</a:t>
            </a:r>
          </a:p>
          <a:p>
            <a:r>
              <a:rPr lang="en-AU" sz="2400" b="1" dirty="0"/>
              <a:t> ( 12 Weeks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46886" y="786244"/>
            <a:ext cx="1512168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Domain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76708" y="1875656"/>
            <a:ext cx="1512168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Specific Measurement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38209" y="3907740"/>
            <a:ext cx="1512168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Specific Metric 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148619" y="4815678"/>
            <a:ext cx="1512168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Method of Aggregation </a:t>
            </a:r>
          </a:p>
        </p:txBody>
      </p:sp>
      <p:cxnSp>
        <p:nvCxnSpPr>
          <p:cNvPr id="12" name="Straight Connector 11"/>
          <p:cNvCxnSpPr/>
          <p:nvPr/>
        </p:nvCxnSpPr>
        <p:spPr>
          <a:xfrm flipV="1">
            <a:off x="3347864" y="1477887"/>
            <a:ext cx="4637915" cy="6897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2789824" y="803912"/>
            <a:ext cx="1879044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Glycaemic control  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241135" y="771568"/>
            <a:ext cx="1512168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Inflammation 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976620" y="778425"/>
            <a:ext cx="1366078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Lipid profile  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3347864" y="1165394"/>
            <a:ext cx="0" cy="3292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5568212" y="1165394"/>
            <a:ext cx="0" cy="3292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985779" y="1155576"/>
            <a:ext cx="0" cy="3292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3347864" y="1494602"/>
            <a:ext cx="0" cy="35022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568212" y="1494602"/>
            <a:ext cx="0" cy="36004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7985779" y="1484784"/>
            <a:ext cx="0" cy="36004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740796" y="1849677"/>
            <a:ext cx="1592883" cy="1200329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HbA1c</a:t>
            </a:r>
          </a:p>
          <a:p>
            <a:r>
              <a:rPr lang="en-AU" dirty="0"/>
              <a:t>Fasting glucose</a:t>
            </a:r>
          </a:p>
          <a:p>
            <a:r>
              <a:rPr lang="en-AU" dirty="0"/>
              <a:t>Insulin</a:t>
            </a:r>
          </a:p>
          <a:p>
            <a:r>
              <a:rPr lang="en-AU" dirty="0"/>
              <a:t>HOMA-IR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647411" y="1881571"/>
            <a:ext cx="1810547" cy="120032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Total cholesterol</a:t>
            </a:r>
          </a:p>
          <a:p>
            <a:r>
              <a:rPr lang="en-AU" dirty="0"/>
              <a:t>Triglycerides</a:t>
            </a:r>
          </a:p>
          <a:p>
            <a:r>
              <a:rPr lang="en-AU" dirty="0"/>
              <a:t>HDL-C, LDL-C</a:t>
            </a:r>
          </a:p>
          <a:p>
            <a:r>
              <a:rPr lang="en-AU" dirty="0"/>
              <a:t>Total:HDL-C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678623" y="1875223"/>
            <a:ext cx="2046366" cy="120032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CRP</a:t>
            </a:r>
          </a:p>
          <a:p>
            <a:r>
              <a:rPr lang="en-AU" dirty="0"/>
              <a:t>FBC</a:t>
            </a:r>
          </a:p>
          <a:p>
            <a:r>
              <a:rPr lang="en-AU" dirty="0"/>
              <a:t>IL-6, IL-1</a:t>
            </a:r>
            <a:r>
              <a:rPr lang="el-GR" dirty="0"/>
              <a:t>β</a:t>
            </a:r>
            <a:endParaRPr lang="en-AU" dirty="0"/>
          </a:p>
          <a:p>
            <a:r>
              <a:rPr lang="en-AU" dirty="0"/>
              <a:t>Adiponectin, Leptin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3400006" y="3701616"/>
            <a:ext cx="4519307" cy="1541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3400006" y="3066484"/>
            <a:ext cx="3557" cy="6351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5431616" y="3081900"/>
            <a:ext cx="0" cy="6351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7919313" y="3081900"/>
            <a:ext cx="1241" cy="64845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5431616" y="3686200"/>
            <a:ext cx="0" cy="36004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779911" y="4046240"/>
            <a:ext cx="3415901" cy="36933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           Change from baseline </a:t>
            </a:r>
          </a:p>
        </p:txBody>
      </p:sp>
      <p:cxnSp>
        <p:nvCxnSpPr>
          <p:cNvPr id="39" name="Straight Arrow Connector 38"/>
          <p:cNvCxnSpPr/>
          <p:nvPr/>
        </p:nvCxnSpPr>
        <p:spPr>
          <a:xfrm flipH="1">
            <a:off x="5431616" y="4415572"/>
            <a:ext cx="2" cy="400106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3781370" y="4842500"/>
            <a:ext cx="3415901" cy="36933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                   Continuous  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753427" y="5466554"/>
            <a:ext cx="3415901" cy="36933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dirty="0"/>
              <a:t>                 Mean or Median </a:t>
            </a:r>
          </a:p>
        </p:txBody>
      </p:sp>
      <p:cxnSp>
        <p:nvCxnSpPr>
          <p:cNvPr id="45" name="Straight Arrow Connector 44"/>
          <p:cNvCxnSpPr/>
          <p:nvPr/>
        </p:nvCxnSpPr>
        <p:spPr>
          <a:xfrm>
            <a:off x="5431616" y="5214247"/>
            <a:ext cx="0" cy="24776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itle 66"/>
          <p:cNvSpPr txBox="1">
            <a:spLocks/>
          </p:cNvSpPr>
          <p:nvPr/>
        </p:nvSpPr>
        <p:spPr>
          <a:xfrm>
            <a:off x="23651" y="74965"/>
            <a:ext cx="8620056" cy="49493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AU" sz="1800" b="1" dirty="0"/>
              <a:t>Additional file 2: Outcome measures </a:t>
            </a:r>
          </a:p>
        </p:txBody>
      </p:sp>
      <p:sp>
        <p:nvSpPr>
          <p:cNvPr id="72" name="Title 70"/>
          <p:cNvSpPr>
            <a:spLocks noGrp="1"/>
          </p:cNvSpPr>
          <p:nvPr>
            <p:ph type="title"/>
          </p:nvPr>
        </p:nvSpPr>
        <p:spPr>
          <a:xfrm>
            <a:off x="83402" y="6006340"/>
            <a:ext cx="8839220" cy="1143000"/>
          </a:xfrm>
        </p:spPr>
        <p:txBody>
          <a:bodyPr>
            <a:normAutofit/>
          </a:bodyPr>
          <a:lstStyle/>
          <a:p>
            <a:pPr algn="l"/>
            <a:r>
              <a:rPr lang="en-AU" sz="1200" dirty="0"/>
              <a:t>Abbreviations: HbA1c-Glycosylated Haemoglobin; HOMA-IR-Homeostatic model assessment for insulin resistance; HDL-C- High density lipoprotein cholesterol; LDL-C-Low density lipoprotein cholesterol; CRP- C reactive protein; FBC-full blood cell count; IL-6&amp;IL-1</a:t>
            </a:r>
            <a:r>
              <a:rPr lang="el-GR" sz="1200" dirty="0"/>
              <a:t>β</a:t>
            </a:r>
            <a:r>
              <a:rPr lang="en-AU" sz="1200" dirty="0"/>
              <a:t>- Interleukin 6 and interleukin 1</a:t>
            </a:r>
            <a:r>
              <a:rPr lang="el-GR" sz="1200" dirty="0"/>
              <a:t>β</a:t>
            </a:r>
            <a:r>
              <a:rPr lang="en-AU" sz="1200" dirty="0"/>
              <a:t>. Blue coloured boxes represent primary outcome measure in this trial. </a:t>
            </a:r>
            <a:endParaRPr lang="en-AU" sz="1400" dirty="0"/>
          </a:p>
        </p:txBody>
      </p:sp>
      <p:sp>
        <p:nvSpPr>
          <p:cNvPr id="73" name="Rectangle 72"/>
          <p:cNvSpPr/>
          <p:nvPr/>
        </p:nvSpPr>
        <p:spPr>
          <a:xfrm>
            <a:off x="2787168" y="1940829"/>
            <a:ext cx="874429" cy="233203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dirty="0">
                <a:solidFill>
                  <a:schemeClr val="tx1"/>
                </a:solidFill>
              </a:rPr>
              <a:t>HbA1c</a:t>
            </a:r>
          </a:p>
        </p:txBody>
      </p:sp>
    </p:spTree>
    <p:extLst>
      <p:ext uri="{BB962C8B-B14F-4D97-AF65-F5344CB8AC3E}">
        <p14:creationId xmlns:p14="http://schemas.microsoft.com/office/powerpoint/2010/main" val="2550851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2</TotalTime>
  <Words>117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Abbreviations: HbA1c-Glycosylated Haemoglobin; HOMA-IR-Homeostatic model assessment for insulin resistance; HDL-C- High density lipoprotein cholesterol; LDL-C-Low density lipoprotein cholesterol; CRP- C reactive protein; FBC-full blood cell count; IL-6&amp;IL-1β- Interleukin 6 and interleukin 1β. Blue coloured boxes represent primary outcome measure in this trial. </vt:lpstr>
    </vt:vector>
  </TitlesOfParts>
  <Company>The University of Newcastle, Austra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stuser1</dc:creator>
  <cp:lastModifiedBy>testuser1</cp:lastModifiedBy>
  <cp:revision>13</cp:revision>
  <cp:lastPrinted>2016-10-24T22:50:28Z</cp:lastPrinted>
  <dcterms:created xsi:type="dcterms:W3CDTF">2016-10-24T07:28:05Z</dcterms:created>
  <dcterms:modified xsi:type="dcterms:W3CDTF">2016-10-25T23:31:58Z</dcterms:modified>
</cp:coreProperties>
</file>